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89281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E34E3-81E3-450B-AF13-D69C9CBA19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105156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5335560"/>
            <a:ext cx="105156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92329-49EB-4EB0-B6D5-0EAEB8341A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6B4483-8245-4F33-B1F2-8EF19EDC8A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237600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237600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533556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533556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533556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6AD19-299B-416D-9B16-EAA2EFD738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2376000"/>
            <a:ext cx="10515600" cy="566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301"/>
              </a:spcBef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74D28-39E9-448C-8C43-58FF8A77E2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1051560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B12DD3-947D-4776-A0C8-3617FAD5C8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8B6D6A-A216-40F5-ABDE-3EA04661E6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524D0-CC0F-4A80-A811-167DEE1D1D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474480"/>
            <a:ext cx="10515600" cy="79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301"/>
              </a:spcBef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CC4B43-BC2E-4690-A613-A6C29B666C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D51C7-4886-42E5-A462-C1B6DC5E71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1A49A-0BE7-4951-ADD2-3693AF5ED0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5335560"/>
            <a:ext cx="105156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C46D17-76C7-4231-9DC9-8993FBAC1C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2376000"/>
            <a:ext cx="1051560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97000" indent="-29700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1" marL="89208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2" marL="1487520" indent="-29700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3" marL="2082960" indent="-29700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4" marL="267804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5" marL="267804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6" marL="267804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8275680"/>
            <a:ext cx="274320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5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5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8275680"/>
            <a:ext cx="411480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8275680"/>
            <a:ext cx="274320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5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577A855-F090-4692-96CF-DB0313B33296}" type="slidenum">
              <a:rPr b="0" lang="zh-CN" sz="15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20" descr=""/>
          <p:cNvPicPr/>
          <p:nvPr/>
        </p:nvPicPr>
        <p:blipFill>
          <a:blip r:embed="rId1"/>
          <a:stretch/>
        </p:blipFill>
        <p:spPr>
          <a:xfrm>
            <a:off x="1501920" y="1084320"/>
            <a:ext cx="9186840" cy="5224320"/>
          </a:xfrm>
          <a:prstGeom prst="rect">
            <a:avLst/>
          </a:prstGeom>
          <a:ln w="0">
            <a:noFill/>
          </a:ln>
        </p:spPr>
      </p:pic>
      <p:sp>
        <p:nvSpPr>
          <p:cNvPr id="42" name="文本框 7080"/>
          <p:cNvSpPr/>
          <p:nvPr/>
        </p:nvSpPr>
        <p:spPr>
          <a:xfrm>
            <a:off x="2295000" y="6541920"/>
            <a:ext cx="838296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等线"/>
              </a:rPr>
              <a:t>Figure S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等线"/>
              </a:rPr>
              <a:t>. Representative results of MLPA.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等线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等线"/>
              </a:rPr>
              <a:t>A,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等线"/>
              </a:rPr>
              <a:t>Representative result of one case with MYD88 wildtype and amplification of MDM2 and other genes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等线"/>
              </a:rPr>
              <a:t>B,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等线"/>
              </a:rPr>
              <a:t> Representative result of the other case with MYD88 L265P mutation and CDKN2A deletion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3-14T04:27:50Z</dcterms:created>
  <dc:creator>XMX</dc:creator>
  <dc:description/>
  <dc:language>en-US</dc:language>
  <cp:lastModifiedBy>XMX</cp:lastModifiedBy>
  <cp:lastPrinted>2019-03-19T11:17:35Z</cp:lastPrinted>
  <dcterms:modified xsi:type="dcterms:W3CDTF">2020-06-14T13:03:18Z</dcterms:modified>
  <cp:revision>175</cp:revision>
  <dc:subject/>
  <dc:title>PowerPoint 演示文稿</dc:title>
</cp:coreProperties>
</file>